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72" r:id="rId2"/>
    <p:sldId id="278" r:id="rId3"/>
    <p:sldId id="274" r:id="rId4"/>
    <p:sldId id="276" r:id="rId5"/>
    <p:sldId id="277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229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BAD093C-436C-44B2-B759-B84FFA8DBD76}" type="datetimeFigureOut">
              <a:rPr lang="zh-CN" altLang="en-US" smtClean="0"/>
              <a:t>2023/9/2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FB98D34-2100-483A-AF5B-C84C1740135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46847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8EB35C2-1F79-4EFB-917A-66784CE352D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386FBAF8-AC77-482A-BC77-548995F4527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14FD8B9-99B4-4B68-BB11-06FC52319E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D24A7-E5BB-470D-B553-D85FCB24091E}" type="datetimeFigureOut">
              <a:rPr lang="zh-CN" altLang="en-US" smtClean="0"/>
              <a:t>2023/9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D50EC08-8B92-46AA-9435-7C3612D5E4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2400C8E-6D6D-4F03-80E1-E185AFA52A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C80F3-E56F-482D-BF33-BFFCADD6E6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39258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45B10EC-9091-4CD2-8FC1-C70D8097BC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33EDDC9-33E9-4C6B-AF42-859FCADDB5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78CAD2E-ADF9-4A16-B83A-58D0728811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D24A7-E5BB-470D-B553-D85FCB24091E}" type="datetimeFigureOut">
              <a:rPr lang="zh-CN" altLang="en-US" smtClean="0"/>
              <a:t>2023/9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B0A22A7-78E0-400E-ABCC-2A068FB356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9740B76-ADF2-4B8C-AEC5-5236952698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C80F3-E56F-482D-BF33-BFFCADD6E6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8900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103246A9-E709-4E62-A7AA-AEFDABBB11A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5A79AE4-FF81-4D63-964F-76C8B410341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C9C651A-71ED-4E95-878E-EF53275ABC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D24A7-E5BB-470D-B553-D85FCB24091E}" type="datetimeFigureOut">
              <a:rPr lang="zh-CN" altLang="en-US" smtClean="0"/>
              <a:t>2023/9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DDAB741-63A4-44BC-9B00-B8F8A514AA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66065B2-5C16-4380-B2FE-3BFBBDFCD9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C80F3-E56F-482D-BF33-BFFCADD6E6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61860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7908476-4256-4592-AC1A-1CBD394F6B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0E67BF4-B0C5-4C5E-BA85-7F29BF477E1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2331AAE-1DBE-435E-9C67-ECA62F1131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D24A7-E5BB-470D-B553-D85FCB24091E}" type="datetimeFigureOut">
              <a:rPr lang="zh-CN" altLang="en-US" smtClean="0"/>
              <a:t>2023/9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57DC8EA-0975-41AD-9435-4C4FE3E7F0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73ADB16-527C-4BC7-AE4C-A035679D2E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C80F3-E56F-482D-BF33-BFFCADD6E6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08146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9632867-CFD5-479C-9556-5CFE94D7FA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838CB73-F41C-48E6-9DD0-23D1328528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167188A-C0C8-4AE0-A4FA-A4177C7328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D24A7-E5BB-470D-B553-D85FCB24091E}" type="datetimeFigureOut">
              <a:rPr lang="zh-CN" altLang="en-US" smtClean="0"/>
              <a:t>2023/9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6E19D32-0A6E-44B6-BB17-79F18A2E34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9EC29C9-D142-464B-9E2B-A37EF6A88D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C80F3-E56F-482D-BF33-BFFCADD6E6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352068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ABCBBBB-4A8F-4B68-8E70-4340A6C5C9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FED8CCA-CF20-4CB9-B4A3-404E411CCB7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6C0A244-7F69-45E9-A8D3-0975AAA65A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9408EE6-F0E5-4E23-A80E-F6E4A39BDA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D24A7-E5BB-470D-B553-D85FCB24091E}" type="datetimeFigureOut">
              <a:rPr lang="zh-CN" altLang="en-US" smtClean="0"/>
              <a:t>2023/9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0D9C26D-F16B-4FBB-BC42-624EEE8E03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2D9B1D1-DFD3-47CE-BC65-7ECD611CD8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C80F3-E56F-482D-BF33-BFFCADD6E6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92748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B45F7FB-2A99-464A-8B68-58494F59C6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6FC3F37-123A-402A-8518-A51CE2789D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9B2A985-050E-4048-8FC1-33E1292CAA0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2BF80F82-F346-4D33-9060-5720220E4E6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4EC7B6DF-561A-450F-8671-ED03DA00FAF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81D914FD-54C2-486E-B5F1-1C7A171089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D24A7-E5BB-470D-B553-D85FCB24091E}" type="datetimeFigureOut">
              <a:rPr lang="zh-CN" altLang="en-US" smtClean="0"/>
              <a:t>2023/9/2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6F646EEF-9718-4312-8C3C-F9A29FAC94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6B971492-7889-4416-BD54-6E02B002F1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C80F3-E56F-482D-BF33-BFFCADD6E6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726483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B79C0F9-7439-44A8-913F-8388DA66B4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75C0C39D-3AD2-4C1A-9219-02A651A28F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D24A7-E5BB-470D-B553-D85FCB24091E}" type="datetimeFigureOut">
              <a:rPr lang="zh-CN" altLang="en-US" smtClean="0"/>
              <a:t>2023/9/2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784E0169-A47B-477F-AE32-9E117E1F2A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61E5C87F-3683-492B-8C20-8030804C0D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C80F3-E56F-482D-BF33-BFFCADD6E6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41450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94179258-EE82-4E37-8D33-82D605DB04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D24A7-E5BB-470D-B553-D85FCB24091E}" type="datetimeFigureOut">
              <a:rPr lang="zh-CN" altLang="en-US" smtClean="0"/>
              <a:t>2023/9/2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61AE8D7D-1478-4075-AC99-D2C8EBD747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054F73B7-868B-49A8-A035-22C9496ED4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C80F3-E56F-482D-BF33-BFFCADD6E6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99062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B59CEB2-B55D-4BA2-83B6-F19478668C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9B29C5A-03D3-4041-A148-E3B1B1CE101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484CF8C-3358-4609-8C16-B436ABBD18F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5F4BDCA-7EA5-401F-BEF5-6445C90ABA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D24A7-E5BB-470D-B553-D85FCB24091E}" type="datetimeFigureOut">
              <a:rPr lang="zh-CN" altLang="en-US" smtClean="0"/>
              <a:t>2023/9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1F19E23E-1EF0-4B30-AADB-DF763696A0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634AC0E-ADAA-422D-81B2-9759628575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C80F3-E56F-482D-BF33-BFFCADD6E6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614627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DF99E5A-0DB8-44DD-B889-722D93F983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9786FB7F-44A6-4E1D-B2E4-97F12B13AC6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75EBDBC-F1DF-4B30-96C5-953FC1ACA3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4EDBC96-68F9-47A3-95FD-2303D491F9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AD24A7-E5BB-470D-B553-D85FCB24091E}" type="datetimeFigureOut">
              <a:rPr lang="zh-CN" altLang="en-US" smtClean="0"/>
              <a:t>2023/9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3963EB0-8B71-4F31-81F0-FE71F3C09C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5879D57-D0BE-41E6-9373-E647FDA48B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CC80F3-E56F-482D-BF33-BFFCADD6E6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67279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734F284D-16B6-4D72-97E8-463CB334F8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A38EF53-1A15-4E37-A777-10DC215F40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FE8744F-9278-452E-AE01-F2334582E63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AD24A7-E5BB-470D-B553-D85FCB24091E}" type="datetimeFigureOut">
              <a:rPr lang="zh-CN" altLang="en-US" smtClean="0"/>
              <a:t>2023/9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30F3ECE-CED8-45EC-A172-FD4FA541517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FEBEEA5-C62F-4760-914D-FD789E4E3A8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CC80F3-E56F-482D-BF33-BFFCADD6E65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379773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7">
            <a:extLst>
              <a:ext uri="{FF2B5EF4-FFF2-40B4-BE49-F238E27FC236}">
                <a16:creationId xmlns:a16="http://schemas.microsoft.com/office/drawing/2014/main" id="{FB3C0998-2CD2-0282-8C7A-E4F47B1CD282}"/>
              </a:ext>
            </a:extLst>
          </p:cNvPr>
          <p:cNvSpPr txBox="1"/>
          <p:nvPr/>
        </p:nvSpPr>
        <p:spPr>
          <a:xfrm>
            <a:off x="2373479" y="5796138"/>
            <a:ext cx="832434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Supplementary Gel for Figure 1D (upper panel in MCF-7 and MDA-MB-231 cells)</a:t>
            </a:r>
            <a:endParaRPr lang="zh-CN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CA6A6C44-F667-0CCD-F304-8ED8D9FFF6D5}"/>
              </a:ext>
            </a:extLst>
          </p:cNvPr>
          <p:cNvSpPr txBox="1"/>
          <p:nvPr/>
        </p:nvSpPr>
        <p:spPr>
          <a:xfrm>
            <a:off x="752223" y="1412769"/>
            <a:ext cx="1621256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ABCB1</a:t>
            </a: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170 kDa</a:t>
            </a:r>
            <a:endParaRPr lang="en-US" altLang="zh-CN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69F39BCC-973D-1AFC-4084-CA3C8D1BE0D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48627" y="768954"/>
            <a:ext cx="4047373" cy="1814612"/>
          </a:xfrm>
          <a:prstGeom prst="rect">
            <a:avLst/>
          </a:prstGeom>
          <a:ln w="9525">
            <a:solidFill>
              <a:srgbClr val="FF0000"/>
            </a:solidFill>
          </a:ln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0AD7C47E-311C-E025-D0EE-5548F8B7454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87026" y="611304"/>
            <a:ext cx="4047373" cy="1972262"/>
          </a:xfrm>
          <a:prstGeom prst="rect">
            <a:avLst/>
          </a:prstGeom>
          <a:ln w="9525">
            <a:solidFill>
              <a:srgbClr val="FF0000"/>
            </a:solidFill>
          </a:ln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4600A3A6-6DEF-2AA0-DAE1-D1D5470B37B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97857" y="2750975"/>
            <a:ext cx="4398143" cy="1972262"/>
          </a:xfrm>
          <a:prstGeom prst="rect">
            <a:avLst/>
          </a:prstGeom>
          <a:ln w="9525">
            <a:solidFill>
              <a:srgbClr val="FF0000"/>
            </a:solidFill>
          </a:ln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2B7AC5C8-E5EA-1309-189A-E03B46FFAA0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364705" y="2666810"/>
            <a:ext cx="4292014" cy="2056427"/>
          </a:xfrm>
          <a:prstGeom prst="rect">
            <a:avLst/>
          </a:prstGeom>
          <a:ln w="9525">
            <a:solidFill>
              <a:srgbClr val="FF0000"/>
            </a:solidFill>
          </a:ln>
        </p:spPr>
      </p:pic>
      <p:sp>
        <p:nvSpPr>
          <p:cNvPr id="14" name="TextBox 24">
            <a:extLst>
              <a:ext uri="{FF2B5EF4-FFF2-40B4-BE49-F238E27FC236}">
                <a16:creationId xmlns:a16="http://schemas.microsoft.com/office/drawing/2014/main" id="{77FFA62D-3815-605C-0680-B7EC5B80D8E3}"/>
              </a:ext>
            </a:extLst>
          </p:cNvPr>
          <p:cNvSpPr txBox="1"/>
          <p:nvPr/>
        </p:nvSpPr>
        <p:spPr>
          <a:xfrm rot="19606602">
            <a:off x="2965274" y="4304334"/>
            <a:ext cx="12731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h-NC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33">
            <a:extLst>
              <a:ext uri="{FF2B5EF4-FFF2-40B4-BE49-F238E27FC236}">
                <a16:creationId xmlns:a16="http://schemas.microsoft.com/office/drawing/2014/main" id="{87B8F926-A2EA-6D27-81A3-C9B577EEAC4C}"/>
              </a:ext>
            </a:extLst>
          </p:cNvPr>
          <p:cNvSpPr txBox="1"/>
          <p:nvPr/>
        </p:nvSpPr>
        <p:spPr>
          <a:xfrm rot="19606602">
            <a:off x="2959730" y="4441305"/>
            <a:ext cx="22251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h-A1BG-AS1-1</a:t>
            </a:r>
          </a:p>
        </p:txBody>
      </p:sp>
      <p:sp>
        <p:nvSpPr>
          <p:cNvPr id="16" name="TextBox 33">
            <a:extLst>
              <a:ext uri="{FF2B5EF4-FFF2-40B4-BE49-F238E27FC236}">
                <a16:creationId xmlns:a16="http://schemas.microsoft.com/office/drawing/2014/main" id="{A9059DB5-6855-E2B2-0E4F-70C684F1FCB4}"/>
              </a:ext>
            </a:extLst>
          </p:cNvPr>
          <p:cNvSpPr txBox="1"/>
          <p:nvPr/>
        </p:nvSpPr>
        <p:spPr>
          <a:xfrm rot="19606602">
            <a:off x="3610263" y="4441237"/>
            <a:ext cx="22254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h-A1BG-AS1-2</a:t>
            </a:r>
          </a:p>
        </p:txBody>
      </p:sp>
      <p:sp>
        <p:nvSpPr>
          <p:cNvPr id="17" name="TextBox 24">
            <a:extLst>
              <a:ext uri="{FF2B5EF4-FFF2-40B4-BE49-F238E27FC236}">
                <a16:creationId xmlns:a16="http://schemas.microsoft.com/office/drawing/2014/main" id="{920DCFD4-F450-2AEB-CF20-6CDAC5C98B98}"/>
              </a:ext>
            </a:extLst>
          </p:cNvPr>
          <p:cNvSpPr txBox="1"/>
          <p:nvPr/>
        </p:nvSpPr>
        <p:spPr>
          <a:xfrm rot="19606602">
            <a:off x="7236485" y="4083683"/>
            <a:ext cx="12731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h-NC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33">
            <a:extLst>
              <a:ext uri="{FF2B5EF4-FFF2-40B4-BE49-F238E27FC236}">
                <a16:creationId xmlns:a16="http://schemas.microsoft.com/office/drawing/2014/main" id="{E7A2DBA8-0994-0112-DA7F-0694BA3886D3}"/>
              </a:ext>
            </a:extLst>
          </p:cNvPr>
          <p:cNvSpPr txBox="1"/>
          <p:nvPr/>
        </p:nvSpPr>
        <p:spPr>
          <a:xfrm rot="19606602">
            <a:off x="7230941" y="4220654"/>
            <a:ext cx="22251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h-A1BG-AS1-1</a:t>
            </a:r>
          </a:p>
        </p:txBody>
      </p:sp>
      <p:sp>
        <p:nvSpPr>
          <p:cNvPr id="19" name="TextBox 33">
            <a:extLst>
              <a:ext uri="{FF2B5EF4-FFF2-40B4-BE49-F238E27FC236}">
                <a16:creationId xmlns:a16="http://schemas.microsoft.com/office/drawing/2014/main" id="{55FC9958-3B99-75CD-665C-E1E1C812B87F}"/>
              </a:ext>
            </a:extLst>
          </p:cNvPr>
          <p:cNvSpPr txBox="1"/>
          <p:nvPr/>
        </p:nvSpPr>
        <p:spPr>
          <a:xfrm rot="19606602">
            <a:off x="7881474" y="4220586"/>
            <a:ext cx="22254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h-A1BG-AS1-2</a:t>
            </a: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B000980B-CB8D-E8A4-E21F-A1C04846E9DE}"/>
              </a:ext>
            </a:extLst>
          </p:cNvPr>
          <p:cNvSpPr txBox="1"/>
          <p:nvPr/>
        </p:nvSpPr>
        <p:spPr>
          <a:xfrm>
            <a:off x="562120" y="3533568"/>
            <a:ext cx="101829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37 kDa</a:t>
            </a:r>
            <a:endParaRPr lang="en-US" altLang="zh-CN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3FE10FF7-1151-EBAE-D73E-E4F6E53E5D23}"/>
              </a:ext>
            </a:extLst>
          </p:cNvPr>
          <p:cNvSpPr txBox="1"/>
          <p:nvPr/>
        </p:nvSpPr>
        <p:spPr>
          <a:xfrm>
            <a:off x="3387782" y="315918"/>
            <a:ext cx="101829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MCF-7</a:t>
            </a: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28F2DB6C-834F-712A-8CA3-8FAAF00C3235}"/>
              </a:ext>
            </a:extLst>
          </p:cNvPr>
          <p:cNvSpPr txBox="1"/>
          <p:nvPr/>
        </p:nvSpPr>
        <p:spPr>
          <a:xfrm>
            <a:off x="7692866" y="221675"/>
            <a:ext cx="166569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MDA-MB-231</a:t>
            </a:r>
          </a:p>
        </p:txBody>
      </p:sp>
    </p:spTree>
    <p:extLst>
      <p:ext uri="{BB962C8B-B14F-4D97-AF65-F5344CB8AC3E}">
        <p14:creationId xmlns:p14="http://schemas.microsoft.com/office/powerpoint/2010/main" val="10805853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5A3064D3-855A-4B2C-B653-3ED429C83CB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80546" y="1227219"/>
            <a:ext cx="2358190" cy="2358190"/>
          </a:xfrm>
          <a:prstGeom prst="rect">
            <a:avLst/>
          </a:prstGeom>
          <a:ln>
            <a:solidFill>
              <a:srgbClr val="FF0000"/>
            </a:solidFill>
          </a:ln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7B9AA785-B161-4B5C-879C-1C3B2EDBDA0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12932" y="3969080"/>
            <a:ext cx="2231608" cy="1741743"/>
          </a:xfrm>
          <a:prstGeom prst="rect">
            <a:avLst/>
          </a:prstGeom>
          <a:ln>
            <a:solidFill>
              <a:srgbClr val="FF0000"/>
            </a:solidFill>
          </a:ln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9E87D6B5-30EC-4FD4-9540-6680EE0E046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086350" y="968394"/>
            <a:ext cx="2358190" cy="2875841"/>
          </a:xfrm>
          <a:prstGeom prst="rect">
            <a:avLst/>
          </a:prstGeom>
          <a:ln>
            <a:solidFill>
              <a:srgbClr val="FF0000"/>
            </a:solidFill>
          </a:ln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01BBCBC8-1B2B-43C3-8B26-149ED0C1B17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686802" y="3729789"/>
            <a:ext cx="2451934" cy="1789733"/>
          </a:xfrm>
          <a:prstGeom prst="rect">
            <a:avLst/>
          </a:prstGeom>
          <a:ln>
            <a:solidFill>
              <a:srgbClr val="FF0000"/>
            </a:solidFill>
          </a:ln>
        </p:spPr>
      </p:pic>
      <p:sp>
        <p:nvSpPr>
          <p:cNvPr id="12" name="TextBox 24">
            <a:extLst>
              <a:ext uri="{FF2B5EF4-FFF2-40B4-BE49-F238E27FC236}">
                <a16:creationId xmlns:a16="http://schemas.microsoft.com/office/drawing/2014/main" id="{A7AC4237-5C54-4565-8B20-DAC7479FA7FC}"/>
              </a:ext>
            </a:extLst>
          </p:cNvPr>
          <p:cNvSpPr txBox="1"/>
          <p:nvPr/>
        </p:nvSpPr>
        <p:spPr>
          <a:xfrm rot="19606602">
            <a:off x="3766435" y="5360836"/>
            <a:ext cx="8438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Vector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33">
            <a:extLst>
              <a:ext uri="{FF2B5EF4-FFF2-40B4-BE49-F238E27FC236}">
                <a16:creationId xmlns:a16="http://schemas.microsoft.com/office/drawing/2014/main" id="{8FD3877E-9892-4281-82CE-DC7059D14F75}"/>
              </a:ext>
            </a:extLst>
          </p:cNvPr>
          <p:cNvSpPr txBox="1"/>
          <p:nvPr/>
        </p:nvSpPr>
        <p:spPr>
          <a:xfrm rot="19606602">
            <a:off x="4212111" y="5114511"/>
            <a:ext cx="147489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pcDNA3.1-A1BG-AS1-1</a:t>
            </a:r>
          </a:p>
        </p:txBody>
      </p:sp>
      <p:sp>
        <p:nvSpPr>
          <p:cNvPr id="14" name="TextBox 24">
            <a:extLst>
              <a:ext uri="{FF2B5EF4-FFF2-40B4-BE49-F238E27FC236}">
                <a16:creationId xmlns:a16="http://schemas.microsoft.com/office/drawing/2014/main" id="{573AC9A1-7055-4527-AD25-5C5FE3806294}"/>
              </a:ext>
            </a:extLst>
          </p:cNvPr>
          <p:cNvSpPr txBox="1"/>
          <p:nvPr/>
        </p:nvSpPr>
        <p:spPr>
          <a:xfrm rot="19606602">
            <a:off x="7334669" y="5107777"/>
            <a:ext cx="8438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Vector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33">
            <a:extLst>
              <a:ext uri="{FF2B5EF4-FFF2-40B4-BE49-F238E27FC236}">
                <a16:creationId xmlns:a16="http://schemas.microsoft.com/office/drawing/2014/main" id="{C1CC8393-B896-4C3E-8BC5-583E569A8F6B}"/>
              </a:ext>
            </a:extLst>
          </p:cNvPr>
          <p:cNvSpPr txBox="1"/>
          <p:nvPr/>
        </p:nvSpPr>
        <p:spPr>
          <a:xfrm rot="19606602">
            <a:off x="7780345" y="4861452"/>
            <a:ext cx="147489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pcDNA3.1-A1BG-AS1-1</a:t>
            </a: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FB3D57E3-1ECF-48C1-93D6-902F82A5C465}"/>
              </a:ext>
            </a:extLst>
          </p:cNvPr>
          <p:cNvSpPr txBox="1"/>
          <p:nvPr/>
        </p:nvSpPr>
        <p:spPr>
          <a:xfrm>
            <a:off x="1886953" y="6133794"/>
            <a:ext cx="832434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Supplementary Gel for Figure 1E (upper panel in MCF-7 and MDA-MB-231 cells)</a:t>
            </a:r>
            <a:endParaRPr lang="zh-CN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4EF41A71-3BB8-4F0C-939F-33AD9B1B5683}"/>
              </a:ext>
            </a:extLst>
          </p:cNvPr>
          <p:cNvSpPr txBox="1"/>
          <p:nvPr/>
        </p:nvSpPr>
        <p:spPr>
          <a:xfrm>
            <a:off x="1750344" y="1883196"/>
            <a:ext cx="1621256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ABCB1</a:t>
            </a: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170 kDa</a:t>
            </a:r>
            <a:endParaRPr lang="en-US" altLang="zh-CN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9BBD969A-8B09-4F93-B9B8-6FD3E1A4E61C}"/>
              </a:ext>
            </a:extLst>
          </p:cNvPr>
          <p:cNvSpPr txBox="1"/>
          <p:nvPr/>
        </p:nvSpPr>
        <p:spPr>
          <a:xfrm>
            <a:off x="1954571" y="4578592"/>
            <a:ext cx="101829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37 kDa</a:t>
            </a:r>
            <a:endParaRPr lang="en-US" altLang="zh-CN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58DCD1DF-CF18-4A3B-86EE-F9ABED81AB61}"/>
              </a:ext>
            </a:extLst>
          </p:cNvPr>
          <p:cNvSpPr txBox="1"/>
          <p:nvPr/>
        </p:nvSpPr>
        <p:spPr>
          <a:xfrm>
            <a:off x="3931266" y="643689"/>
            <a:ext cx="101829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MCF-7</a:t>
            </a: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B4FF34D9-3327-450F-98AF-C761552EA657}"/>
              </a:ext>
            </a:extLst>
          </p:cNvPr>
          <p:cNvSpPr txBox="1"/>
          <p:nvPr/>
        </p:nvSpPr>
        <p:spPr>
          <a:xfrm>
            <a:off x="7361016" y="733500"/>
            <a:ext cx="166569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MDA-MB-231</a:t>
            </a:r>
          </a:p>
        </p:txBody>
      </p:sp>
    </p:spTree>
    <p:extLst>
      <p:ext uri="{BB962C8B-B14F-4D97-AF65-F5344CB8AC3E}">
        <p14:creationId xmlns:p14="http://schemas.microsoft.com/office/powerpoint/2010/main" val="368066444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图片 24">
            <a:extLst>
              <a:ext uri="{FF2B5EF4-FFF2-40B4-BE49-F238E27FC236}">
                <a16:creationId xmlns:a16="http://schemas.microsoft.com/office/drawing/2014/main" id="{048813A5-A974-D9B0-B363-5B58F204235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17456" y="2852621"/>
            <a:ext cx="3184094" cy="1783946"/>
          </a:xfrm>
          <a:prstGeom prst="rect">
            <a:avLst/>
          </a:prstGeom>
          <a:ln>
            <a:solidFill>
              <a:srgbClr val="FF0000"/>
            </a:solidFill>
          </a:ln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EE184E55-4450-F22A-050E-DC0C9EBBD35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394923" y="2831038"/>
            <a:ext cx="3797585" cy="1783946"/>
          </a:xfrm>
          <a:prstGeom prst="rect">
            <a:avLst/>
          </a:prstGeom>
          <a:ln>
            <a:solidFill>
              <a:srgbClr val="FF0000"/>
            </a:solidFill>
          </a:ln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BF978C67-3D73-2BA6-4D2C-30B39E5405A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518266" y="776829"/>
            <a:ext cx="3650515" cy="1918210"/>
          </a:xfrm>
          <a:prstGeom prst="rect">
            <a:avLst/>
          </a:prstGeom>
          <a:ln>
            <a:solidFill>
              <a:srgbClr val="FF0000"/>
            </a:solidFill>
          </a:ln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FB3C0998-2CD2-0282-8C7A-E4F47B1CD282}"/>
              </a:ext>
            </a:extLst>
          </p:cNvPr>
          <p:cNvSpPr txBox="1"/>
          <p:nvPr/>
        </p:nvSpPr>
        <p:spPr>
          <a:xfrm>
            <a:off x="1844432" y="5387125"/>
            <a:ext cx="832434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Supplementary Gel for Figure 4A (upper panel in MCF-7 and MDA-MB-231 cells)</a:t>
            </a:r>
            <a:endParaRPr lang="zh-CN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CA6A6C44-F667-0CCD-F304-8ED8D9FFF6D5}"/>
              </a:ext>
            </a:extLst>
          </p:cNvPr>
          <p:cNvSpPr txBox="1"/>
          <p:nvPr/>
        </p:nvSpPr>
        <p:spPr>
          <a:xfrm>
            <a:off x="752223" y="1412769"/>
            <a:ext cx="1621256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ABCB1</a:t>
            </a: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170 kDa</a:t>
            </a:r>
            <a:endParaRPr lang="en-US" altLang="zh-CN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24">
            <a:extLst>
              <a:ext uri="{FF2B5EF4-FFF2-40B4-BE49-F238E27FC236}">
                <a16:creationId xmlns:a16="http://schemas.microsoft.com/office/drawing/2014/main" id="{77FFA62D-3815-605C-0680-B7EC5B80D8E3}"/>
              </a:ext>
            </a:extLst>
          </p:cNvPr>
          <p:cNvSpPr txBox="1"/>
          <p:nvPr/>
        </p:nvSpPr>
        <p:spPr>
          <a:xfrm rot="19606602">
            <a:off x="2455264" y="4249619"/>
            <a:ext cx="12731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h-NC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33">
            <a:extLst>
              <a:ext uri="{FF2B5EF4-FFF2-40B4-BE49-F238E27FC236}">
                <a16:creationId xmlns:a16="http://schemas.microsoft.com/office/drawing/2014/main" id="{87B8F926-A2EA-6D27-81A3-C9B577EEAC4C}"/>
              </a:ext>
            </a:extLst>
          </p:cNvPr>
          <p:cNvSpPr txBox="1"/>
          <p:nvPr/>
        </p:nvSpPr>
        <p:spPr>
          <a:xfrm rot="19606602">
            <a:off x="2449720" y="4386590"/>
            <a:ext cx="22251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h-A1BG-AS1-1</a:t>
            </a:r>
          </a:p>
        </p:txBody>
      </p:sp>
      <p:sp>
        <p:nvSpPr>
          <p:cNvPr id="16" name="TextBox 33">
            <a:extLst>
              <a:ext uri="{FF2B5EF4-FFF2-40B4-BE49-F238E27FC236}">
                <a16:creationId xmlns:a16="http://schemas.microsoft.com/office/drawing/2014/main" id="{A9059DB5-6855-E2B2-0E4F-70C684F1FCB4}"/>
              </a:ext>
            </a:extLst>
          </p:cNvPr>
          <p:cNvSpPr txBox="1"/>
          <p:nvPr/>
        </p:nvSpPr>
        <p:spPr>
          <a:xfrm rot="19606602">
            <a:off x="3100253" y="4386522"/>
            <a:ext cx="22254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h-A1BG-AS1-2</a:t>
            </a:r>
          </a:p>
        </p:txBody>
      </p:sp>
      <p:sp>
        <p:nvSpPr>
          <p:cNvPr id="17" name="TextBox 24">
            <a:extLst>
              <a:ext uri="{FF2B5EF4-FFF2-40B4-BE49-F238E27FC236}">
                <a16:creationId xmlns:a16="http://schemas.microsoft.com/office/drawing/2014/main" id="{920DCFD4-F450-2AEB-CF20-6CDAC5C98B98}"/>
              </a:ext>
            </a:extLst>
          </p:cNvPr>
          <p:cNvSpPr txBox="1"/>
          <p:nvPr/>
        </p:nvSpPr>
        <p:spPr>
          <a:xfrm rot="19606602">
            <a:off x="7301704" y="4176379"/>
            <a:ext cx="12731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h-NC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33">
            <a:extLst>
              <a:ext uri="{FF2B5EF4-FFF2-40B4-BE49-F238E27FC236}">
                <a16:creationId xmlns:a16="http://schemas.microsoft.com/office/drawing/2014/main" id="{E7A2DBA8-0994-0112-DA7F-0694BA3886D3}"/>
              </a:ext>
            </a:extLst>
          </p:cNvPr>
          <p:cNvSpPr txBox="1"/>
          <p:nvPr/>
        </p:nvSpPr>
        <p:spPr>
          <a:xfrm rot="19606602">
            <a:off x="7296160" y="4313350"/>
            <a:ext cx="22251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h-A1BG-AS1-1</a:t>
            </a:r>
          </a:p>
        </p:txBody>
      </p:sp>
      <p:sp>
        <p:nvSpPr>
          <p:cNvPr id="19" name="TextBox 33">
            <a:extLst>
              <a:ext uri="{FF2B5EF4-FFF2-40B4-BE49-F238E27FC236}">
                <a16:creationId xmlns:a16="http://schemas.microsoft.com/office/drawing/2014/main" id="{55FC9958-3B99-75CD-665C-E1E1C812B87F}"/>
              </a:ext>
            </a:extLst>
          </p:cNvPr>
          <p:cNvSpPr txBox="1"/>
          <p:nvPr/>
        </p:nvSpPr>
        <p:spPr>
          <a:xfrm rot="19606602">
            <a:off x="7946693" y="4313282"/>
            <a:ext cx="22254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h-A1BG-AS1-2</a:t>
            </a: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B000980B-CB8D-E8A4-E21F-A1C04846E9DE}"/>
              </a:ext>
            </a:extLst>
          </p:cNvPr>
          <p:cNvSpPr txBox="1"/>
          <p:nvPr/>
        </p:nvSpPr>
        <p:spPr>
          <a:xfrm>
            <a:off x="562120" y="3533568"/>
            <a:ext cx="101829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37 kDa</a:t>
            </a:r>
            <a:endParaRPr lang="en-US" altLang="zh-CN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3FE10FF7-1151-EBAE-D73E-E4F6E53E5D23}"/>
              </a:ext>
            </a:extLst>
          </p:cNvPr>
          <p:cNvSpPr txBox="1"/>
          <p:nvPr/>
        </p:nvSpPr>
        <p:spPr>
          <a:xfrm>
            <a:off x="3387782" y="315918"/>
            <a:ext cx="101829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MCF-7</a:t>
            </a: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28F2DB6C-834F-712A-8CA3-8FAAF00C3235}"/>
              </a:ext>
            </a:extLst>
          </p:cNvPr>
          <p:cNvSpPr txBox="1"/>
          <p:nvPr/>
        </p:nvSpPr>
        <p:spPr>
          <a:xfrm>
            <a:off x="7692866" y="221675"/>
            <a:ext cx="166569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MDA-MB-231</a:t>
            </a: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2C701437-95EE-2EE9-63C1-4D61B0F977C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835885" y="936964"/>
            <a:ext cx="3103793" cy="1841543"/>
          </a:xfrm>
          <a:prstGeom prst="rect">
            <a:avLst/>
          </a:prstGeom>
          <a:ln>
            <a:solidFill>
              <a:srgbClr val="FF0000"/>
            </a:solidFill>
          </a:ln>
        </p:spPr>
      </p:pic>
    </p:spTree>
    <p:extLst>
      <p:ext uri="{BB962C8B-B14F-4D97-AF65-F5344CB8AC3E}">
        <p14:creationId xmlns:p14="http://schemas.microsoft.com/office/powerpoint/2010/main" val="362248796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0DE43224-DE64-6E3F-5ACF-D8F7FB03813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66296" y="2960383"/>
            <a:ext cx="3843154" cy="2033701"/>
          </a:xfrm>
          <a:prstGeom prst="rect">
            <a:avLst/>
          </a:prstGeom>
          <a:ln>
            <a:solidFill>
              <a:srgbClr val="FF0000"/>
            </a:solidFill>
          </a:ln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60A44503-1278-98AF-96E1-E7C47FD82C3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98098" y="2749148"/>
            <a:ext cx="3843154" cy="2030861"/>
          </a:xfrm>
          <a:prstGeom prst="rect">
            <a:avLst/>
          </a:prstGeom>
          <a:ln>
            <a:solidFill>
              <a:srgbClr val="FF0000"/>
            </a:solidFill>
          </a:ln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FB3C0998-2CD2-0282-8C7A-E4F47B1CD282}"/>
              </a:ext>
            </a:extLst>
          </p:cNvPr>
          <p:cNvSpPr txBox="1"/>
          <p:nvPr/>
        </p:nvSpPr>
        <p:spPr>
          <a:xfrm>
            <a:off x="1933825" y="5895367"/>
            <a:ext cx="832434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Supplementary Gel for Figure 4C (upper panel in MCF-7 and MDA-MB-231 cells)</a:t>
            </a:r>
            <a:endParaRPr lang="zh-CN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CA6A6C44-F667-0CCD-F304-8ED8D9FFF6D5}"/>
              </a:ext>
            </a:extLst>
          </p:cNvPr>
          <p:cNvSpPr txBox="1"/>
          <p:nvPr/>
        </p:nvSpPr>
        <p:spPr>
          <a:xfrm>
            <a:off x="752223" y="1412769"/>
            <a:ext cx="1621256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ABCB1</a:t>
            </a: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170 kDa</a:t>
            </a:r>
            <a:endParaRPr lang="en-US" altLang="zh-CN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24">
            <a:extLst>
              <a:ext uri="{FF2B5EF4-FFF2-40B4-BE49-F238E27FC236}">
                <a16:creationId xmlns:a16="http://schemas.microsoft.com/office/drawing/2014/main" id="{77FFA62D-3815-605C-0680-B7EC5B80D8E3}"/>
              </a:ext>
            </a:extLst>
          </p:cNvPr>
          <p:cNvSpPr txBox="1"/>
          <p:nvPr/>
        </p:nvSpPr>
        <p:spPr>
          <a:xfrm rot="19606602">
            <a:off x="2455264" y="4478222"/>
            <a:ext cx="12731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h-NC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33">
            <a:extLst>
              <a:ext uri="{FF2B5EF4-FFF2-40B4-BE49-F238E27FC236}">
                <a16:creationId xmlns:a16="http://schemas.microsoft.com/office/drawing/2014/main" id="{87B8F926-A2EA-6D27-81A3-C9B577EEAC4C}"/>
              </a:ext>
            </a:extLst>
          </p:cNvPr>
          <p:cNvSpPr txBox="1"/>
          <p:nvPr/>
        </p:nvSpPr>
        <p:spPr>
          <a:xfrm rot="19606602">
            <a:off x="2449720" y="4615193"/>
            <a:ext cx="22251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h-A1BG-AS1-1</a:t>
            </a:r>
          </a:p>
        </p:txBody>
      </p:sp>
      <p:sp>
        <p:nvSpPr>
          <p:cNvPr id="16" name="TextBox 33">
            <a:extLst>
              <a:ext uri="{FF2B5EF4-FFF2-40B4-BE49-F238E27FC236}">
                <a16:creationId xmlns:a16="http://schemas.microsoft.com/office/drawing/2014/main" id="{A9059DB5-6855-E2B2-0E4F-70C684F1FCB4}"/>
              </a:ext>
            </a:extLst>
          </p:cNvPr>
          <p:cNvSpPr txBox="1"/>
          <p:nvPr/>
        </p:nvSpPr>
        <p:spPr>
          <a:xfrm rot="19606602">
            <a:off x="3100253" y="4615125"/>
            <a:ext cx="22254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h-A1BG-AS1-2</a:t>
            </a:r>
          </a:p>
        </p:txBody>
      </p:sp>
      <p:sp>
        <p:nvSpPr>
          <p:cNvPr id="17" name="TextBox 24">
            <a:extLst>
              <a:ext uri="{FF2B5EF4-FFF2-40B4-BE49-F238E27FC236}">
                <a16:creationId xmlns:a16="http://schemas.microsoft.com/office/drawing/2014/main" id="{920DCFD4-F450-2AEB-CF20-6CDAC5C98B98}"/>
              </a:ext>
            </a:extLst>
          </p:cNvPr>
          <p:cNvSpPr txBox="1"/>
          <p:nvPr/>
        </p:nvSpPr>
        <p:spPr>
          <a:xfrm rot="19606602">
            <a:off x="7409992" y="4296694"/>
            <a:ext cx="12731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h-NC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33">
            <a:extLst>
              <a:ext uri="{FF2B5EF4-FFF2-40B4-BE49-F238E27FC236}">
                <a16:creationId xmlns:a16="http://schemas.microsoft.com/office/drawing/2014/main" id="{E7A2DBA8-0994-0112-DA7F-0694BA3886D3}"/>
              </a:ext>
            </a:extLst>
          </p:cNvPr>
          <p:cNvSpPr txBox="1"/>
          <p:nvPr/>
        </p:nvSpPr>
        <p:spPr>
          <a:xfrm rot="19606602">
            <a:off x="7404448" y="4433665"/>
            <a:ext cx="22251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h-A1BG-AS1-1</a:t>
            </a:r>
          </a:p>
        </p:txBody>
      </p:sp>
      <p:sp>
        <p:nvSpPr>
          <p:cNvPr id="19" name="TextBox 33">
            <a:extLst>
              <a:ext uri="{FF2B5EF4-FFF2-40B4-BE49-F238E27FC236}">
                <a16:creationId xmlns:a16="http://schemas.microsoft.com/office/drawing/2014/main" id="{55FC9958-3B99-75CD-665C-E1E1C812B87F}"/>
              </a:ext>
            </a:extLst>
          </p:cNvPr>
          <p:cNvSpPr txBox="1"/>
          <p:nvPr/>
        </p:nvSpPr>
        <p:spPr>
          <a:xfrm rot="19606602">
            <a:off x="8054981" y="4433597"/>
            <a:ext cx="22254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h-A1BG-AS1-2</a:t>
            </a: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B000980B-CB8D-E8A4-E21F-A1C04846E9DE}"/>
              </a:ext>
            </a:extLst>
          </p:cNvPr>
          <p:cNvSpPr txBox="1"/>
          <p:nvPr/>
        </p:nvSpPr>
        <p:spPr>
          <a:xfrm>
            <a:off x="562120" y="3533568"/>
            <a:ext cx="101829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37 kDa</a:t>
            </a:r>
            <a:endParaRPr lang="en-US" altLang="zh-CN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3FE10FF7-1151-EBAE-D73E-E4F6E53E5D23}"/>
              </a:ext>
            </a:extLst>
          </p:cNvPr>
          <p:cNvSpPr txBox="1"/>
          <p:nvPr/>
        </p:nvSpPr>
        <p:spPr>
          <a:xfrm>
            <a:off x="3387782" y="315918"/>
            <a:ext cx="101829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MCF-7</a:t>
            </a: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28F2DB6C-834F-712A-8CA3-8FAAF00C3235}"/>
              </a:ext>
            </a:extLst>
          </p:cNvPr>
          <p:cNvSpPr txBox="1"/>
          <p:nvPr/>
        </p:nvSpPr>
        <p:spPr>
          <a:xfrm>
            <a:off x="7692866" y="221675"/>
            <a:ext cx="166569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MDA-MB-231</a:t>
            </a:r>
          </a:p>
        </p:txBody>
      </p:sp>
      <p:pic>
        <p:nvPicPr>
          <p:cNvPr id="22" name="图片 21">
            <a:extLst>
              <a:ext uri="{FF2B5EF4-FFF2-40B4-BE49-F238E27FC236}">
                <a16:creationId xmlns:a16="http://schemas.microsoft.com/office/drawing/2014/main" id="{471CE0B4-5E08-38A1-B623-97B9C04AFD2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640690" y="822692"/>
            <a:ext cx="3770048" cy="1826483"/>
          </a:xfrm>
          <a:prstGeom prst="rect">
            <a:avLst/>
          </a:prstGeom>
          <a:ln>
            <a:solidFill>
              <a:srgbClr val="FF0000"/>
            </a:solidFill>
          </a:ln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5086C402-C833-217C-315E-16AFCD3C2B9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802850" y="840724"/>
            <a:ext cx="3770046" cy="2031433"/>
          </a:xfrm>
          <a:prstGeom prst="rect">
            <a:avLst/>
          </a:prstGeom>
          <a:ln>
            <a:solidFill>
              <a:srgbClr val="FF0000"/>
            </a:solidFill>
          </a:ln>
        </p:spPr>
      </p:pic>
    </p:spTree>
    <p:extLst>
      <p:ext uri="{BB962C8B-B14F-4D97-AF65-F5344CB8AC3E}">
        <p14:creationId xmlns:p14="http://schemas.microsoft.com/office/powerpoint/2010/main" val="61287174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>
            <a:extLst>
              <a:ext uri="{FF2B5EF4-FFF2-40B4-BE49-F238E27FC236}">
                <a16:creationId xmlns:a16="http://schemas.microsoft.com/office/drawing/2014/main" id="{746ACCA3-8C7E-2244-0F0D-3E19D7A3B13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0800000">
            <a:off x="1904281" y="2017546"/>
            <a:ext cx="4048125" cy="2228850"/>
          </a:xfrm>
          <a:prstGeom prst="rect">
            <a:avLst/>
          </a:prstGeom>
          <a:ln>
            <a:solidFill>
              <a:srgbClr val="FF0000"/>
            </a:solidFill>
          </a:ln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2BA0EB87-0E12-3433-CA4F-5A666C799B6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81933" y="1998496"/>
            <a:ext cx="4838700" cy="2266950"/>
          </a:xfrm>
          <a:prstGeom prst="rect">
            <a:avLst/>
          </a:prstGeom>
          <a:ln>
            <a:solidFill>
              <a:srgbClr val="FF0000"/>
            </a:solidFill>
          </a:ln>
        </p:spPr>
      </p:pic>
      <p:sp>
        <p:nvSpPr>
          <p:cNvPr id="8" name="文本框 7">
            <a:extLst>
              <a:ext uri="{FF2B5EF4-FFF2-40B4-BE49-F238E27FC236}">
                <a16:creationId xmlns:a16="http://schemas.microsoft.com/office/drawing/2014/main" id="{FB3C0998-2CD2-0282-8C7A-E4F47B1CD282}"/>
              </a:ext>
            </a:extLst>
          </p:cNvPr>
          <p:cNvSpPr txBox="1"/>
          <p:nvPr/>
        </p:nvSpPr>
        <p:spPr>
          <a:xfrm>
            <a:off x="4723855" y="5316704"/>
            <a:ext cx="38774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Supplementary Gel for Figure 6E</a:t>
            </a:r>
            <a:endParaRPr lang="zh-CN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CA6A6C44-F667-0CCD-F304-8ED8D9FFF6D5}"/>
              </a:ext>
            </a:extLst>
          </p:cNvPr>
          <p:cNvSpPr txBox="1"/>
          <p:nvPr/>
        </p:nvSpPr>
        <p:spPr>
          <a:xfrm>
            <a:off x="640549" y="2829650"/>
            <a:ext cx="1621256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ABCB1</a:t>
            </a: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170 kDa</a:t>
            </a:r>
            <a:endParaRPr lang="en-US" altLang="zh-CN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24">
            <a:extLst>
              <a:ext uri="{FF2B5EF4-FFF2-40B4-BE49-F238E27FC236}">
                <a16:creationId xmlns:a16="http://schemas.microsoft.com/office/drawing/2014/main" id="{77FFA62D-3815-605C-0680-B7EC5B80D8E3}"/>
              </a:ext>
            </a:extLst>
          </p:cNvPr>
          <p:cNvSpPr txBox="1"/>
          <p:nvPr/>
        </p:nvSpPr>
        <p:spPr>
          <a:xfrm rot="19606602">
            <a:off x="2674972" y="3484641"/>
            <a:ext cx="12731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h-NC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33">
            <a:extLst>
              <a:ext uri="{FF2B5EF4-FFF2-40B4-BE49-F238E27FC236}">
                <a16:creationId xmlns:a16="http://schemas.microsoft.com/office/drawing/2014/main" id="{87B8F926-A2EA-6D27-81A3-C9B577EEAC4C}"/>
              </a:ext>
            </a:extLst>
          </p:cNvPr>
          <p:cNvSpPr txBox="1"/>
          <p:nvPr/>
        </p:nvSpPr>
        <p:spPr>
          <a:xfrm rot="19606602">
            <a:off x="3821778" y="3414084"/>
            <a:ext cx="22251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h-A1BG-AS1-1</a:t>
            </a:r>
          </a:p>
        </p:txBody>
      </p:sp>
      <p:sp>
        <p:nvSpPr>
          <p:cNvPr id="17" name="TextBox 24">
            <a:extLst>
              <a:ext uri="{FF2B5EF4-FFF2-40B4-BE49-F238E27FC236}">
                <a16:creationId xmlns:a16="http://schemas.microsoft.com/office/drawing/2014/main" id="{920DCFD4-F450-2AEB-CF20-6CDAC5C98B98}"/>
              </a:ext>
            </a:extLst>
          </p:cNvPr>
          <p:cNvSpPr txBox="1"/>
          <p:nvPr/>
        </p:nvSpPr>
        <p:spPr>
          <a:xfrm rot="19606602">
            <a:off x="7327888" y="3654546"/>
            <a:ext cx="127310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h-NC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33">
            <a:extLst>
              <a:ext uri="{FF2B5EF4-FFF2-40B4-BE49-F238E27FC236}">
                <a16:creationId xmlns:a16="http://schemas.microsoft.com/office/drawing/2014/main" id="{E7A2DBA8-0994-0112-DA7F-0694BA3886D3}"/>
              </a:ext>
            </a:extLst>
          </p:cNvPr>
          <p:cNvSpPr txBox="1"/>
          <p:nvPr/>
        </p:nvSpPr>
        <p:spPr>
          <a:xfrm rot="19606602">
            <a:off x="8313701" y="3836880"/>
            <a:ext cx="22251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sh-A1BG-AS1-1</a:t>
            </a: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B000980B-CB8D-E8A4-E21F-A1C04846E9DE}"/>
              </a:ext>
            </a:extLst>
          </p:cNvPr>
          <p:cNvSpPr txBox="1"/>
          <p:nvPr/>
        </p:nvSpPr>
        <p:spPr>
          <a:xfrm>
            <a:off x="11020633" y="2878457"/>
            <a:ext cx="101829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37 kDa</a:t>
            </a:r>
            <a:endParaRPr lang="en-US" altLang="zh-CN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813488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28</TotalTime>
  <Words>125</Words>
  <Application>Microsoft Office PowerPoint</Application>
  <PresentationFormat>宽屏</PresentationFormat>
  <Paragraphs>59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9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Dunxin</cp:lastModifiedBy>
  <cp:revision>50</cp:revision>
  <dcterms:created xsi:type="dcterms:W3CDTF">2020-08-26T08:49:18Z</dcterms:created>
  <dcterms:modified xsi:type="dcterms:W3CDTF">2023-09-28T02:53:24Z</dcterms:modified>
</cp:coreProperties>
</file>